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heme/theme2.xml" ContentType="application/vnd.openxmlformats-officedocument.theme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7" r:id="rId2"/>
    <p:sldId id="271" r:id="rId3"/>
    <p:sldId id="272" r:id="rId4"/>
  </p:sldIdLst>
  <p:sldSz cx="6858000" cy="9902825"/>
  <p:notesSz cx="6858000" cy="9144000"/>
  <p:custDataLst>
    <p:tags r:id="rId6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04" userDrawn="1">
          <p15:clr>
            <a:srgbClr val="A4A3A4"/>
          </p15:clr>
        </p15:guide>
        <p15:guide id="2" pos="219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39" d="100"/>
          <a:sy n="39" d="100"/>
        </p:scale>
        <p:origin x="2076" y="66"/>
      </p:cViewPr>
      <p:guideLst>
        <p:guide orient="horz" pos="3104"/>
        <p:guide pos="219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476" y="1143000"/>
            <a:ext cx="2137048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4346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674325" y="1320480"/>
            <a:ext cx="5512050" cy="3711901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674325" y="5141554"/>
            <a:ext cx="5512050" cy="212628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25" y="1117729"/>
            <a:ext cx="6172200" cy="791768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25" y="3587131"/>
            <a:ext cx="5512050" cy="147124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25" y="5141554"/>
            <a:ext cx="5512050" cy="68103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42225" y="2152278"/>
            <a:ext cx="6170175" cy="687273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119825" y="5557453"/>
            <a:ext cx="4369950" cy="110733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119825" y="6664785"/>
            <a:ext cx="4369950" cy="1252896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42225" y="2167875"/>
            <a:ext cx="2911950" cy="685713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606525" y="2167875"/>
            <a:ext cx="2911950" cy="6857138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42225" y="2063900"/>
            <a:ext cx="3005100" cy="55106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42225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2053111"/>
            <a:ext cx="3005100" cy="55106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677351"/>
            <a:ext cx="3005100" cy="634766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78587"/>
            <a:ext cx="6170175" cy="1018953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225" y="2245856"/>
            <a:ext cx="2943606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100" y="2245856"/>
            <a:ext cx="2940300" cy="665438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5/2/26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5757075" y="1320480"/>
            <a:ext cx="587250" cy="726264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514350" y="1320480"/>
            <a:ext cx="5157675" cy="726264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342225" y="878587"/>
            <a:ext cx="6170175" cy="1018953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342225" y="2152278"/>
            <a:ext cx="6170175" cy="68727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3442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5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2315250" y="9118590"/>
            <a:ext cx="222750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4993650" y="9118590"/>
            <a:ext cx="1518750" cy="4574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9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9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9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9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5.xml"/><Relationship Id="rId1" Type="http://schemas.openxmlformats.org/officeDocument/2006/relationships/tags" Target="../tags/tag64.xml"/><Relationship Id="rId5" Type="http://schemas.openxmlformats.org/officeDocument/2006/relationships/image" Target="../media/image2.png"/><Relationship Id="rId4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tags" Target="../tags/tag68.xml"/><Relationship Id="rId2" Type="http://schemas.openxmlformats.org/officeDocument/2006/relationships/tags" Target="../tags/tag67.xml"/><Relationship Id="rId1" Type="http://schemas.openxmlformats.org/officeDocument/2006/relationships/tags" Target="../tags/tag66.xml"/><Relationship Id="rId4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6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942340" y="4767580"/>
            <a:ext cx="497332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 S1. Total body weight gain and brain-to-body weight ratio.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340310" y="1501140"/>
            <a:ext cx="419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6721" y="1663730"/>
            <a:ext cx="2304729" cy="272337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4236721" y="1501140"/>
            <a:ext cx="419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5" name="图片 4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5"/>
          <a:stretch>
            <a:fillRect/>
          </a:stretch>
        </p:blipFill>
        <p:spPr>
          <a:xfrm>
            <a:off x="1061085" y="2056130"/>
            <a:ext cx="2273935" cy="2237105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/>
          <p:cNvSpPr txBox="1"/>
          <p:nvPr/>
        </p:nvSpPr>
        <p:spPr>
          <a:xfrm>
            <a:off x="805815" y="879157"/>
            <a:ext cx="5080000" cy="30670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 algn="ctr"/>
            <a:r>
              <a:rPr lang="en-US" sz="1400" b="1">
                <a:solidFill>
                  <a:srgbClr val="000000"/>
                </a:solidFill>
                <a:latin typeface="Times New Roman Regular" panose="02020603050405020304" charset="0"/>
                <a:cs typeface="-webkit-standard" charset="0"/>
              </a:rPr>
              <a:t>Table S1. Basic Feed and Its Component Analysis</a:t>
            </a:r>
            <a:endParaRPr lang="en-US" altLang="en-US" sz="1400" b="1">
              <a:solidFill>
                <a:srgbClr val="000000"/>
              </a:solidFill>
              <a:latin typeface="Times New Roman Regular" panose="02020603050405020304" charset="0"/>
              <a:cs typeface="-webkit-standard" charset="0"/>
            </a:endParaRPr>
          </a:p>
        </p:txBody>
      </p:sp>
      <p:graphicFrame>
        <p:nvGraphicFramePr>
          <p:cNvPr id="16" name="表格 15"/>
          <p:cNvGraphicFramePr/>
          <p:nvPr/>
        </p:nvGraphicFramePr>
        <p:xfrm>
          <a:off x="805815" y="1247457"/>
          <a:ext cx="5411788" cy="1706880"/>
        </p:xfrm>
        <a:graphic>
          <a:graphicData uri="http://schemas.openxmlformats.org/drawingml/2006/table">
            <a:tbl>
              <a:tblPr/>
              <a:tblGrid>
                <a:gridCol w="2705100"/>
                <a:gridCol w="2706688"/>
              </a:tblGrid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Nutritional Content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omposition Content</a:t>
                      </a:r>
                      <a:r>
                        <a:rPr lang="en-US" sz="1400" b="0">
                          <a:solidFill>
                            <a:srgbClr val="000000"/>
                          </a:solidFill>
                          <a:latin typeface="-webkit-standard" charset="0"/>
                          <a:cs typeface="-webkit-standard" charset="0"/>
                        </a:rPr>
                        <a:t>(</a:t>
                      </a: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g/kg</a:t>
                      </a:r>
                      <a:r>
                        <a:rPr lang="en-US" sz="1400" b="0">
                          <a:solidFill>
                            <a:srgbClr val="000000"/>
                          </a:solidFill>
                          <a:latin typeface="-webkit-standard" charset="0"/>
                          <a:cs typeface="-webkit-standard" charset="0"/>
                        </a:rPr>
                        <a:t>)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Moistur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≦100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rude Protein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≧180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rude Fat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≧40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rude Fiber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≦50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rude Ash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≦80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alcium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0-18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Total Phosphorus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6-12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7" name="文本框 16"/>
          <p:cNvSpPr txBox="1"/>
          <p:nvPr/>
        </p:nvSpPr>
        <p:spPr>
          <a:xfrm>
            <a:off x="1043305" y="3567112"/>
            <a:ext cx="5080000" cy="52197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 algn="ctr"/>
            <a:r>
              <a:rPr lang="en-US" sz="1400" b="1">
                <a:solidFill>
                  <a:srgbClr val="000000"/>
                </a:solidFill>
                <a:latin typeface="Times New Roman Regular" panose="02020603050405020304" charset="0"/>
                <a:cs typeface="-webkit-standard" charset="0"/>
              </a:rPr>
              <a:t>Table S2. Amino Acid Nutritional Content and Its Concentration</a:t>
            </a:r>
            <a:endParaRPr lang="en-US" altLang="en-US" sz="1400" b="1">
              <a:solidFill>
                <a:srgbClr val="000000"/>
              </a:solidFill>
              <a:latin typeface="Times New Roman Regular" panose="02020603050405020304" charset="0"/>
              <a:cs typeface="-webkit-standard" charset="0"/>
            </a:endParaRPr>
          </a:p>
        </p:txBody>
      </p:sp>
      <p:graphicFrame>
        <p:nvGraphicFramePr>
          <p:cNvPr id="18" name="表格 17"/>
          <p:cNvGraphicFramePr/>
          <p:nvPr/>
        </p:nvGraphicFramePr>
        <p:xfrm>
          <a:off x="889000" y="3882072"/>
          <a:ext cx="5411788" cy="2346960"/>
        </p:xfrm>
        <a:graphic>
          <a:graphicData uri="http://schemas.openxmlformats.org/drawingml/2006/table">
            <a:tbl>
              <a:tblPr/>
              <a:tblGrid>
                <a:gridCol w="2705100"/>
                <a:gridCol w="2706688"/>
              </a:tblGrid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Nutritional Content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omposition Content(g/kg)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Lys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3.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133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Methionine + Cyste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7.6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Argin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1.9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1336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Histid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6.0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Tryptophan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3.6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Phenylalanine + Tyrosine</a:t>
                      </a:r>
                    </a:p>
                    <a:p>
                      <a:pPr indent="0" algn="ctr">
                        <a:buNone/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  <a:sym typeface="+mn-ea"/>
                        </a:rPr>
                        <a:t>Threon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  <a:sym typeface="+mn-ea"/>
                        </a:rPr>
                        <a:t>Leuc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  <a:sym typeface="+mn-ea"/>
                        </a:rPr>
                        <a:t>Isoleuc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  <a:sym typeface="+mn-ea"/>
                        </a:rPr>
                        <a:t>Val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4.9</a:t>
                      </a:r>
                    </a:p>
                    <a:p>
                      <a:pPr indent="0" algn="ctr">
                        <a:buNone/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  <a:sym typeface="+mn-ea"/>
                        </a:rPr>
                        <a:t>8.7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  <a:sym typeface="+mn-ea"/>
                        </a:rPr>
                        <a:t>14.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  <a:sym typeface="+mn-ea"/>
                        </a:rPr>
                        <a:t>9.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  <a:sym typeface="+mn-ea"/>
                        </a:rPr>
                        <a:t>10.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24" name="文本框 23"/>
          <p:cNvSpPr txBox="1"/>
          <p:nvPr>
            <p:custDataLst>
              <p:tags r:id="rId2"/>
            </p:custDataLst>
          </p:nvPr>
        </p:nvSpPr>
        <p:spPr>
          <a:xfrm>
            <a:off x="805815" y="6704013"/>
            <a:ext cx="5080000" cy="30670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 algn="ctr"/>
            <a:r>
              <a:rPr lang="en-US" sz="1400" b="1">
                <a:solidFill>
                  <a:srgbClr val="000000"/>
                </a:solidFill>
                <a:latin typeface="Times New Roman Regular" panose="02020603050405020304" charset="0"/>
                <a:cs typeface="-webkit-standard" charset="0"/>
              </a:rPr>
              <a:t>Table S3. Mineral Components and Their Concentrations</a:t>
            </a:r>
            <a:endParaRPr lang="en-US" altLang="en-US" sz="1400" b="1">
              <a:solidFill>
                <a:srgbClr val="000000"/>
              </a:solidFill>
              <a:latin typeface="Times New Roman Regular" panose="02020603050405020304" charset="0"/>
              <a:cs typeface="-webkit-standard" charset="0"/>
            </a:endParaRPr>
          </a:p>
        </p:txBody>
      </p:sp>
      <p:graphicFrame>
        <p:nvGraphicFramePr>
          <p:cNvPr id="25" name="表格 24"/>
          <p:cNvGraphicFramePr/>
          <p:nvPr>
            <p:custDataLst>
              <p:tags r:id="rId3"/>
            </p:custDataLst>
          </p:nvPr>
        </p:nvGraphicFramePr>
        <p:xfrm>
          <a:off x="711200" y="7027227"/>
          <a:ext cx="5411788" cy="2133600"/>
        </p:xfrm>
        <a:graphic>
          <a:graphicData uri="http://schemas.openxmlformats.org/drawingml/2006/table">
            <a:tbl>
              <a:tblPr/>
              <a:tblGrid>
                <a:gridCol w="2705100"/>
                <a:gridCol w="2706688"/>
              </a:tblGrid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Nutritional Content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omposition Content</a:t>
                      </a:r>
                      <a:r>
                        <a:rPr lang="en-US" sz="1400" b="0">
                          <a:solidFill>
                            <a:srgbClr val="000000"/>
                          </a:solidFill>
                          <a:latin typeface="-webkit-standard" charset="0"/>
                          <a:cs typeface="-webkit-standard" charset="0"/>
                        </a:rPr>
                        <a:t>(</a:t>
                      </a: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g/kg</a:t>
                      </a:r>
                      <a:r>
                        <a:rPr lang="en-US" sz="1400" b="0">
                          <a:solidFill>
                            <a:srgbClr val="000000"/>
                          </a:solidFill>
                          <a:latin typeface="-webkit-standard" charset="0"/>
                          <a:cs typeface="-webkit-standard" charset="0"/>
                        </a:rPr>
                        <a:t>)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Magnesium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2.27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Potassium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6.53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Sodium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3.11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Iron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9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Manganes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0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opper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4.1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Zinc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Iod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0.5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Selenium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0.12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26" name="文本框 25"/>
          <p:cNvSpPr txBox="1"/>
          <p:nvPr/>
        </p:nvSpPr>
        <p:spPr>
          <a:xfrm>
            <a:off x="285115" y="90805"/>
            <a:ext cx="64090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b="1">
                <a:latin typeface="Times New Roman Bold" panose="02020603050405020304" charset="0"/>
                <a:cs typeface="Times New Roman Bold" panose="02020603050405020304" charset="0"/>
              </a:rPr>
              <a:t>Supplementary Tables 1-4</a:t>
            </a:r>
            <a:r>
              <a:rPr lang="en-US" altLang="zh-CN" b="1">
                <a:latin typeface="Times New Roman Bold" panose="02020603050405020304" charset="0"/>
                <a:cs typeface="Times New Roman Bold" panose="02020603050405020304" charset="0"/>
              </a:rPr>
              <a:t> </a:t>
            </a:r>
            <a:r>
              <a:rPr lang="zh-CN" altLang="en-US" b="1">
                <a:latin typeface="Times New Roman Bold" panose="02020603050405020304" charset="0"/>
                <a:cs typeface="Times New Roman Bold" panose="02020603050405020304" charset="0"/>
              </a:rPr>
              <a:t>Diet Composition and Preparation of Freeze-dried Broccoli Powder</a:t>
            </a:r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054735" y="1284923"/>
            <a:ext cx="5080000" cy="30670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 algn="ctr"/>
            <a:r>
              <a:rPr lang="en-US" sz="1400" b="1">
                <a:solidFill>
                  <a:srgbClr val="000000"/>
                </a:solidFill>
                <a:latin typeface="Times New Roman Regular" panose="02020603050405020304" charset="0"/>
                <a:cs typeface="-webkit-standard" charset="0"/>
              </a:rPr>
              <a:t>Table S4. Vitamin Components and Their Concentrations</a:t>
            </a:r>
            <a:endParaRPr lang="en-US" altLang="en-US" sz="1400" b="1">
              <a:solidFill>
                <a:srgbClr val="000000"/>
              </a:solidFill>
              <a:latin typeface="Times New Roman Regular" panose="02020603050405020304" charset="0"/>
              <a:cs typeface="-webkit-standard" charset="0"/>
            </a:endParaRPr>
          </a:p>
        </p:txBody>
      </p:sp>
      <p:graphicFrame>
        <p:nvGraphicFramePr>
          <p:cNvPr id="6" name="表格 5"/>
          <p:cNvGraphicFramePr/>
          <p:nvPr/>
        </p:nvGraphicFramePr>
        <p:xfrm>
          <a:off x="889000" y="1623378"/>
          <a:ext cx="5411788" cy="3200400"/>
        </p:xfrm>
        <a:graphic>
          <a:graphicData uri="http://schemas.openxmlformats.org/drawingml/2006/table">
            <a:tbl>
              <a:tblPr/>
              <a:tblGrid>
                <a:gridCol w="2705100"/>
                <a:gridCol w="2706688"/>
              </a:tblGrid>
              <a:tr h="0">
                <a:tc>
                  <a:txBody>
                    <a:bodyPr/>
                    <a:lstStyle/>
                    <a:p>
                      <a:pPr indent="0" algn="ctr">
                        <a:lnSpc>
                          <a:spcPct val="150000"/>
                        </a:lnSpc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Nutritional Content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omposition Content</a:t>
                      </a:r>
                      <a:r>
                        <a:rPr lang="en-US" sz="1400" b="0">
                          <a:solidFill>
                            <a:srgbClr val="000000"/>
                          </a:solidFill>
                          <a:latin typeface="-webkit-standard" charset="0"/>
                          <a:cs typeface="-webkit-standard" charset="0"/>
                        </a:rPr>
                        <a:t>(</a:t>
                      </a: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IU/kg , mg/kg</a:t>
                      </a:r>
                      <a:r>
                        <a:rPr lang="en-US" sz="1400" b="0">
                          <a:solidFill>
                            <a:srgbClr val="000000"/>
                          </a:solidFill>
                          <a:latin typeface="-webkit-standard" charset="0"/>
                          <a:cs typeface="-webkit-standard" charset="0"/>
                        </a:rPr>
                        <a:t>)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Vitamin A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3692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Vitamin D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noFill/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339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noFill/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Vitamin 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noFill/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15.4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noFill/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Vitamin K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5.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Vitamin B1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Vitamin B2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7.4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Vitamin B6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0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Vitamin B12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0.035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Niacin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74.9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Pantothenic Acid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32.7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Biotin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0.174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Choline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1360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Folic Acid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 Regular" panose="02020603050405020304" charset="0"/>
                          <a:cs typeface="Times New Roman Regular" panose="02020603050405020304" charset="0"/>
                        </a:rPr>
                        <a:t>7.50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 Regular" panose="02020603050405020304" charset="0"/>
                        <a:ea typeface="Times New Roman Regular" panose="02020603050405020304" charset="0"/>
                        <a:cs typeface="Times New Roman Regular" panose="0202060305040502030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DRiYmU3NjExNDVkZDUwZTkwNDlkMWE2Nzc5OWQ5YmU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  <p:tag name="KSO_WM_SPECIAL_SOURCE" val="bdnull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  <p:tag name="KSO_WM_SPECIAL_SOURCE" val="bdnull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  <p:tag name="KSO_WM_SPECIAL_SOURCE" val="bdnull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4</Words>
  <Application>Microsoft Office PowerPoint</Application>
  <PresentationFormat>Custom</PresentationFormat>
  <Paragraphs>9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3" baseType="lpstr">
      <vt:lpstr>微软雅黑</vt:lpstr>
      <vt:lpstr>宋体</vt:lpstr>
      <vt:lpstr>Arial</vt:lpstr>
      <vt:lpstr>Calibri</vt:lpstr>
      <vt:lpstr>Times New Roman</vt:lpstr>
      <vt:lpstr>Times New Roman Bold</vt:lpstr>
      <vt:lpstr>Times New Roman Regular</vt:lpstr>
      <vt:lpstr>-webkit-standard</vt:lpstr>
      <vt:lpstr>Wingdings</vt:lpstr>
      <vt:lpstr>WPS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Madhavi J Jayaraman R</cp:lastModifiedBy>
  <cp:revision>214</cp:revision>
  <dcterms:created xsi:type="dcterms:W3CDTF">2024-12-23T11:09:45Z</dcterms:created>
  <dcterms:modified xsi:type="dcterms:W3CDTF">2025-02-26T14:12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5.2.8766</vt:lpwstr>
  </property>
  <property fmtid="{D5CDD505-2E9C-101B-9397-08002B2CF9AE}" pid="3" name="ICV">
    <vt:lpwstr>28C349731526F2C2F8446967D9D74D67_43</vt:lpwstr>
  </property>
</Properties>
</file>